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69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 varScale="1">
        <p:scale>
          <a:sx n="85" d="100"/>
          <a:sy n="85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7C6AE24-95B7-97A1-2472-3DF4B406F1A5}"/>
              </a:ext>
            </a:extLst>
          </p:cNvPr>
          <p:cNvSpPr txBox="1"/>
          <p:nvPr/>
        </p:nvSpPr>
        <p:spPr>
          <a:xfrm>
            <a:off x="0" y="0"/>
            <a:ext cx="2385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1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C95B61-7CCE-3F1A-707C-04D0A2ED77A0}"/>
              </a:ext>
            </a:extLst>
          </p:cNvPr>
          <p:cNvSpPr txBox="1"/>
          <p:nvPr/>
        </p:nvSpPr>
        <p:spPr>
          <a:xfrm>
            <a:off x="0" y="4789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6DA4DC-62CF-5D87-BECE-69E8E785176C}"/>
              </a:ext>
            </a:extLst>
          </p:cNvPr>
          <p:cNvSpPr txBox="1"/>
          <p:nvPr/>
        </p:nvSpPr>
        <p:spPr>
          <a:xfrm>
            <a:off x="2302606" y="4849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E4F571F-C4D1-3A7D-0039-12B25F23D39C}"/>
              </a:ext>
            </a:extLst>
          </p:cNvPr>
          <p:cNvSpPr txBox="1"/>
          <p:nvPr/>
        </p:nvSpPr>
        <p:spPr>
          <a:xfrm>
            <a:off x="4537698" y="4849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0F85D0-B1BC-2DAF-73F3-A56BB4BF50DD}"/>
              </a:ext>
            </a:extLst>
          </p:cNvPr>
          <p:cNvSpPr txBox="1"/>
          <p:nvPr/>
        </p:nvSpPr>
        <p:spPr>
          <a:xfrm>
            <a:off x="0" y="429871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05C1E2C-4E83-1FB3-CEBB-623842FADAF7}"/>
              </a:ext>
            </a:extLst>
          </p:cNvPr>
          <p:cNvSpPr txBox="1"/>
          <p:nvPr/>
        </p:nvSpPr>
        <p:spPr>
          <a:xfrm>
            <a:off x="2302606" y="429871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437E231-0D4E-D0D2-335F-C45DE5CFB47E}"/>
              </a:ext>
            </a:extLst>
          </p:cNvPr>
          <p:cNvSpPr txBox="1"/>
          <p:nvPr/>
        </p:nvSpPr>
        <p:spPr>
          <a:xfrm>
            <a:off x="4537698" y="429871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D4C72AC-109A-C840-E2EC-55514952F7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1498" y="4578861"/>
            <a:ext cx="2213501" cy="319094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21E9E2B-E025-0D0C-6D18-5D6003C4E8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9350" y="4578857"/>
            <a:ext cx="2213504" cy="319095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008998E-F378-4C73-F7AE-A13F37129E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578857"/>
            <a:ext cx="2213504" cy="319095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7081181-1D2E-3C60-F228-3C44D7A2E2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81498" y="848252"/>
            <a:ext cx="2213504" cy="319095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53AC28D-95AC-3F62-F533-053720DDEC7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09350" y="848252"/>
            <a:ext cx="2213504" cy="319095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570FD9D-F4AE-AA18-BD30-AB7CCB74C4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848251"/>
            <a:ext cx="2213504" cy="319095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3E0FC31-2292-320B-8ADF-FDC23A58F016}"/>
              </a:ext>
            </a:extLst>
          </p:cNvPr>
          <p:cNvSpPr txBox="1"/>
          <p:nvPr/>
        </p:nvSpPr>
        <p:spPr>
          <a:xfrm>
            <a:off x="0" y="8401049"/>
            <a:ext cx="6858000" cy="7463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US" sz="10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10. Overlapping T-cell clonotypes in tumor and pre-REP TIL samples</a:t>
            </a:r>
            <a:endParaRPr lang="fi-FI" sz="10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>
              <a:spcBef>
                <a:spcPts val="300"/>
              </a:spcBef>
            </a:pPr>
            <a:r>
              <a:rPr lang="en-US" sz="1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frequencies of overlapping T-cell clonotypes between the tumor (T) and corresponding pre-REP TIL samples for six patients: A) pt081, B) pt096, C) pt125, D) pt423, E) pt426, and F) pt616). The x- and y-axes were scaled using log-transformation. Spearman’s correlation was used to compare the samples.     </a:t>
            </a:r>
            <a:endParaRPr lang="fi-FI" sz="10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0268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90</TotalTime>
  <Words>87</Words>
  <Application>Microsoft Macintosh PowerPoint</Application>
  <PresentationFormat>A4-paperi (210 x 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30:51Z</dcterms:modified>
</cp:coreProperties>
</file>